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4AC8B-90F1-4E4E-9377-588097BAD9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EC088-5FFE-4F0A-8180-02492AE38D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09E83-5402-43EB-AD7C-7276F7F568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9C0FE-C083-46C7-8D38-28871B2210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3C310-B833-455C-87E3-CDE3E14F27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54580-2D1E-4DD3-8DA1-DC31DC73AA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3D98F-78D1-4AF6-B4E3-14FFCD3CD4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1A0F0-21B3-43B5-82DE-BE5BC2007F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B87D3-EFAC-4424-8885-11AE9A4250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1C277-AD6A-4AF1-972D-1E027F5E35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08E07-839F-4284-98C1-5F01F99651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35B69-ABDE-4E79-9FCE-80338E77B1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A6E04A-D28E-43C6-A2AC-9007B02832D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Calibri"/>
            </a:endParaRPr>
          </a:p>
        </p:txBody>
      </p:sp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>
            <a:off x="179280" y="1447920"/>
            <a:ext cx="8964720" cy="510516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5"/>
          <p:cNvSpPr/>
          <p:nvPr/>
        </p:nvSpPr>
        <p:spPr>
          <a:xfrm>
            <a:off x="304920" y="457200"/>
            <a:ext cx="87627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A. Mean change in birth weight according to the distance to the nearest freeway (restricted to distances between 0 and 1000 m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316800" y="22860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dditional file 6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5"/>
          <p:cNvSpPr/>
          <p:nvPr/>
        </p:nvSpPr>
        <p:spPr>
          <a:xfrm>
            <a:off x="304920" y="725400"/>
            <a:ext cx="868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rt B. Mean change in birth weight according to the distance to the nearest freeway (for the full range of observed distanc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2" descr=""/>
          <p:cNvPicPr/>
          <p:nvPr/>
        </p:nvPicPr>
        <p:blipFill>
          <a:blip r:embed="rId1"/>
          <a:stretch/>
        </p:blipFill>
        <p:spPr>
          <a:xfrm>
            <a:off x="152280" y="1447920"/>
            <a:ext cx="8839440" cy="5105160"/>
          </a:xfrm>
          <a:prstGeom prst="rect">
            <a:avLst/>
          </a:prstGeom>
          <a:ln w="0">
            <a:noFill/>
          </a:ln>
        </p:spPr>
      </p:pic>
      <p:sp>
        <p:nvSpPr>
          <p:cNvPr id="48" name="Rectangle 3"/>
          <p:cNvSpPr/>
          <p:nvPr/>
        </p:nvSpPr>
        <p:spPr>
          <a:xfrm>
            <a:off x="316800" y="228600"/>
            <a:ext cx="185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dditional file 6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aurent, Olivier</dc:creator>
  <dc:description/>
  <dc:language>en-US</dc:language>
  <cp:lastModifiedBy>olaurent</cp:lastModifiedBy>
  <dcterms:modified xsi:type="dcterms:W3CDTF">2012-12-11T02:39:07Z</dcterms:modified>
  <cp:revision>6</cp:revision>
  <dc:subject/>
  <dc:title>Slide 1</dc:title>
</cp:coreProperties>
</file>